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472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3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DC3C88-5D70-47EC-B2B7-5012C44CAFB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1F6511B-AF20-4B23-B29C-7D9B76372F4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434C6B-D9F3-451C-8BC5-B52BE09ED7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05376-66E4-4C33-A81F-D8CED17D9667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577827-783A-4324-B728-A8860ABE54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783888-DD77-46CD-BE8D-25461D716C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F123-B1F0-4916-A337-C724349D7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08696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1BBF56-1693-49D7-A791-C5CA445E57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6631125-2057-4CA1-8644-A4E5B3BC73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FE49A0-A1FD-4DD5-B786-295A52FEAE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05376-66E4-4C33-A81F-D8CED17D9667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D5096C-3F6F-48AF-AF35-44F66E17E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73207C-AD08-48EB-BE59-1839BA69B5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F123-B1F0-4916-A337-C724349D7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60179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1B2FF32-021A-4333-8ABC-90BFE853BF8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66435F9-407A-4A81-889A-5A8D5EA8D0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228251-CE3C-44D4-962E-6DE8BE6BAB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05376-66E4-4C33-A81F-D8CED17D9667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326EB9-59B7-43AC-AF2A-B7AB9B5E22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F548C7-AB66-4DC9-B130-C450D9A478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F123-B1F0-4916-A337-C724349D7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9125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D4BD3C-8EDF-4562-837D-7E7D6105DF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E847F0-AF1F-4084-80F8-215889F7D04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0F9C0D-0E02-4BED-8105-7C00813276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05376-66E4-4C33-A81F-D8CED17D9667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2A1C82-752B-49C7-8927-2DE9D6A9F3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1ED168-876D-49E9-8B3A-455899C13A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F123-B1F0-4916-A337-C724349D7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81585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6EA9AC-2DA4-43DF-BAA5-38071E3553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3B85200-F21B-4C67-86F7-7F826DED97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03B3FE-354A-434A-A1DD-94DDAA021C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05376-66E4-4C33-A81F-D8CED17D9667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2FE98D-1A5D-4EDB-A3A8-3FAFC9F31E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028A35-41D3-4470-8D8E-17EC4CF225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F123-B1F0-4916-A337-C724349D7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83179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C714AF-CE91-49AC-9F17-A76882DD3D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E0652F-7D82-413B-A6B4-F9F687EEC33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8D68FDF-EE9D-4FD4-A791-0471745C16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B924F5-E19F-4684-A590-ACB3F2D3CB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05376-66E4-4C33-A81F-D8CED17D9667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59CBA9C-0EA6-4BCB-8872-EE1F3AD033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A8989B-7498-44D9-9242-D9A306D669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F123-B1F0-4916-A337-C724349D7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1082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41A889-9F09-49B1-86BA-F94ECCB1EF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9DAD9E-6DD1-416A-8D67-F30E04F149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703AE9E-209D-4A1F-9EE2-805822684C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A7697FD-042E-4DE2-A016-A5FE3F69DCC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E1F4E58-9980-4B97-B9C2-123B9072298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535B38F-8D6B-4BFA-9371-5E79742156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05376-66E4-4C33-A81F-D8CED17D9667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DE83723-77DC-4638-91EC-2FDA7E1FF5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66BCEAC-8B2F-4CF3-8A89-351E2678F9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F123-B1F0-4916-A337-C724349D7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2175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B01481-0052-4B91-9FF9-116D7BBCFB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1833570-CD39-44E4-9ED3-A92E0ACC3D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05376-66E4-4C33-A81F-D8CED17D9667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85FFBBA-1096-413A-A203-4BF0694F6A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2CCE8CB-CA33-4320-9C1C-67B4B2C734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F123-B1F0-4916-A337-C724349D7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31536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D33C521-3412-4F68-A846-5A0E4C8A02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05376-66E4-4C33-A81F-D8CED17D9667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813537C-D1B6-403E-B361-53EAA34F2D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331CA45-67D7-47BB-803B-BDC936DDCC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F123-B1F0-4916-A337-C724349D7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48651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962197-3AA3-4415-BD5B-01A9467EB9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B041A4-8145-4712-8152-4933F12ADF9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5E7E97F-B973-4668-8675-CD16062DB4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048BD8-977C-4070-87A4-5096C1DAA4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05376-66E4-4C33-A81F-D8CED17D9667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0A22905-4668-40D6-A797-74BB850E1C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C63B7E5-921E-4370-844B-DA1D7A5C2D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F123-B1F0-4916-A337-C724349D7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1613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28CD80-F900-4EB8-81E8-4298357E7A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897D1F2-5A66-491A-BBB1-93CFDA74F21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17ECFF9-7E3B-4B38-A85F-24E2AD66C8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DEE294C-7B9E-4194-83F6-2E574AB89B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05376-66E4-4C33-A81F-D8CED17D9667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3B8F02E-F826-446F-A715-50EDAF12D1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AC2B1F-61BD-4056-8D48-2FD5FB97DB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F123-B1F0-4916-A337-C724349D7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89043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30BDC21-4AEF-4EB7-811E-CE65C5DAE6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6A22268-5E16-4F88-8916-BB645DB1F9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D95D8E-741D-4AF3-8E8C-10B55141084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C05376-66E4-4C33-A81F-D8CED17D9667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4A4F3D-CD86-4E2B-9B06-E20282FEE12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15AD94-1B42-43EB-94DB-21C4241DBE9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CCF123-B1F0-4916-A337-C724349D7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83295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23">
            <a:extLst>
              <a:ext uri="{FF2B5EF4-FFF2-40B4-BE49-F238E27FC236}">
                <a16:creationId xmlns:a16="http://schemas.microsoft.com/office/drawing/2014/main" id="{7BC9ACA3-98A5-58DE-9438-4C0C603DAE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57458" y="519195"/>
            <a:ext cx="822960" cy="82296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DD315432-D1E5-3BEE-28FE-77091287AD2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09505" y="519195"/>
            <a:ext cx="822960" cy="822960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1A68CE96-D636-040C-928F-59B02C8CF73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05874" y="519195"/>
            <a:ext cx="822960" cy="822960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2D9B46E0-FB8A-09CF-C8E2-96899B09C9A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56858" y="519195"/>
            <a:ext cx="822960" cy="822960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238AFD92-BF4F-A8CD-FE39-B95756B4765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593430" y="519195"/>
            <a:ext cx="822960" cy="82296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90D57CFC-AD5E-45F7-8DC2-D81CEAAF821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15029" y="2615848"/>
            <a:ext cx="2357692" cy="320040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62B8E0A6-5E94-485A-9E14-03620A5A978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491919" y="2614082"/>
            <a:ext cx="2348997" cy="3200400"/>
          </a:xfrm>
          <a:prstGeom prst="rect">
            <a:avLst/>
          </a:prstGeom>
        </p:spPr>
      </p:pic>
      <p:sp>
        <p:nvSpPr>
          <p:cNvPr id="69" name="TextBox 68">
            <a:extLst>
              <a:ext uri="{FF2B5EF4-FFF2-40B4-BE49-F238E27FC236}">
                <a16:creationId xmlns:a16="http://schemas.microsoft.com/office/drawing/2014/main" id="{296EAD9E-93E5-418E-9F73-E5D435DDC2DE}"/>
              </a:ext>
            </a:extLst>
          </p:cNvPr>
          <p:cNvSpPr txBox="1"/>
          <p:nvPr/>
        </p:nvSpPr>
        <p:spPr>
          <a:xfrm>
            <a:off x="1050570" y="2388686"/>
            <a:ext cx="6873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ontrol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690B4561-7A29-4057-B0E1-1FA5E41C241E}"/>
              </a:ext>
            </a:extLst>
          </p:cNvPr>
          <p:cNvSpPr txBox="1"/>
          <p:nvPr/>
        </p:nvSpPr>
        <p:spPr>
          <a:xfrm>
            <a:off x="1627064" y="2388686"/>
            <a:ext cx="8096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S1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E820BB88-4D99-4A8E-9F3C-41AA9A72677E}"/>
              </a:ext>
            </a:extLst>
          </p:cNvPr>
          <p:cNvSpPr txBox="1"/>
          <p:nvPr/>
        </p:nvSpPr>
        <p:spPr>
          <a:xfrm>
            <a:off x="2299792" y="2393640"/>
            <a:ext cx="8096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S2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36367311-41BA-454F-8152-091BAAE6DBD7}"/>
              </a:ext>
            </a:extLst>
          </p:cNvPr>
          <p:cNvSpPr txBox="1"/>
          <p:nvPr/>
        </p:nvSpPr>
        <p:spPr>
          <a:xfrm>
            <a:off x="3631588" y="2360106"/>
            <a:ext cx="6568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ontrol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E2D69E02-FDA6-4420-8EF4-28489C87A98F}"/>
              </a:ext>
            </a:extLst>
          </p:cNvPr>
          <p:cNvSpPr txBox="1"/>
          <p:nvPr/>
        </p:nvSpPr>
        <p:spPr>
          <a:xfrm>
            <a:off x="4277084" y="2365940"/>
            <a:ext cx="8096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M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D90E00C5-BCB5-4518-B2BB-B61C42ADBE2E}"/>
              </a:ext>
            </a:extLst>
          </p:cNvPr>
          <p:cNvSpPr txBox="1"/>
          <p:nvPr/>
        </p:nvSpPr>
        <p:spPr>
          <a:xfrm>
            <a:off x="5058672" y="2360106"/>
            <a:ext cx="8096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NP</a:t>
            </a:r>
          </a:p>
        </p:txBody>
      </p:sp>
      <p:cxnSp>
        <p:nvCxnSpPr>
          <p:cNvPr id="81" name="Straight Arrow Connector 80">
            <a:extLst>
              <a:ext uri="{FF2B5EF4-FFF2-40B4-BE49-F238E27FC236}">
                <a16:creationId xmlns:a16="http://schemas.microsoft.com/office/drawing/2014/main" id="{1F13F0ED-2373-4B92-9C3A-AF1620BEA5E4}"/>
              </a:ext>
            </a:extLst>
          </p:cNvPr>
          <p:cNvCxnSpPr/>
          <p:nvPr/>
        </p:nvCxnSpPr>
        <p:spPr>
          <a:xfrm flipV="1">
            <a:off x="906829" y="5417664"/>
            <a:ext cx="0" cy="54864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3" name="Straight Arrow Connector 82">
            <a:extLst>
              <a:ext uri="{FF2B5EF4-FFF2-40B4-BE49-F238E27FC236}">
                <a16:creationId xmlns:a16="http://schemas.microsoft.com/office/drawing/2014/main" id="{45039FFC-6C55-4310-ACB1-0E260838CFB6}"/>
              </a:ext>
            </a:extLst>
          </p:cNvPr>
          <p:cNvCxnSpPr/>
          <p:nvPr/>
        </p:nvCxnSpPr>
        <p:spPr>
          <a:xfrm>
            <a:off x="906829" y="5966303"/>
            <a:ext cx="457200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4" name="TextBox 83">
            <a:extLst>
              <a:ext uri="{FF2B5EF4-FFF2-40B4-BE49-F238E27FC236}">
                <a16:creationId xmlns:a16="http://schemas.microsoft.com/office/drawing/2014/main" id="{F57060FB-3AD2-4BCE-8C58-100B34420F62}"/>
              </a:ext>
            </a:extLst>
          </p:cNvPr>
          <p:cNvSpPr txBox="1"/>
          <p:nvPr/>
        </p:nvSpPr>
        <p:spPr>
          <a:xfrm>
            <a:off x="4196225" y="2018689"/>
            <a:ext cx="1037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M+NP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C35219BA-364E-435F-9C49-C5F87502BB6C}"/>
              </a:ext>
            </a:extLst>
          </p:cNvPr>
          <p:cNvSpPr txBox="1"/>
          <p:nvPr/>
        </p:nvSpPr>
        <p:spPr>
          <a:xfrm>
            <a:off x="1675193" y="2018689"/>
            <a:ext cx="1037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Spike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9F5980FA-97AB-439E-A67B-702F8E08E59D}"/>
              </a:ext>
            </a:extLst>
          </p:cNvPr>
          <p:cNvSpPr txBox="1"/>
          <p:nvPr/>
        </p:nvSpPr>
        <p:spPr>
          <a:xfrm>
            <a:off x="5805817" y="2927537"/>
            <a:ext cx="1037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OC43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467F79D0-41E8-4DF7-A089-D470F6C99E5E}"/>
              </a:ext>
            </a:extLst>
          </p:cNvPr>
          <p:cNvSpPr txBox="1"/>
          <p:nvPr/>
        </p:nvSpPr>
        <p:spPr>
          <a:xfrm>
            <a:off x="5836087" y="3735850"/>
            <a:ext cx="1037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HKU1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0837517E-B3FE-4A71-B544-63716263DE50}"/>
              </a:ext>
            </a:extLst>
          </p:cNvPr>
          <p:cNvSpPr txBox="1"/>
          <p:nvPr/>
        </p:nvSpPr>
        <p:spPr>
          <a:xfrm>
            <a:off x="5836087" y="4492361"/>
            <a:ext cx="1037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29E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8B3768C0-7F4A-4B8E-8E52-3FC8FC6FB6FD}"/>
              </a:ext>
            </a:extLst>
          </p:cNvPr>
          <p:cNvSpPr txBox="1"/>
          <p:nvPr/>
        </p:nvSpPr>
        <p:spPr>
          <a:xfrm>
            <a:off x="5836087" y="5298712"/>
            <a:ext cx="1037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NL63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1BF6F30D-7A25-4DD7-8E25-482D6DE3583E}"/>
              </a:ext>
            </a:extLst>
          </p:cNvPr>
          <p:cNvSpPr txBox="1"/>
          <p:nvPr/>
        </p:nvSpPr>
        <p:spPr>
          <a:xfrm rot="16200000">
            <a:off x="563718" y="5046945"/>
            <a:ext cx="681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CD4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9E1E91E2-CB75-47E5-8B8B-4FF2282FE1A2}"/>
              </a:ext>
            </a:extLst>
          </p:cNvPr>
          <p:cNvSpPr txBox="1"/>
          <p:nvPr/>
        </p:nvSpPr>
        <p:spPr>
          <a:xfrm>
            <a:off x="1147879" y="5809794"/>
            <a:ext cx="9469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TNFα</a:t>
            </a:r>
          </a:p>
        </p:txBody>
      </p: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756A6A66-CEE6-4F06-90CF-8482E5F32210}"/>
              </a:ext>
            </a:extLst>
          </p:cNvPr>
          <p:cNvCxnSpPr>
            <a:cxnSpLocks/>
          </p:cNvCxnSpPr>
          <p:nvPr/>
        </p:nvCxnSpPr>
        <p:spPr>
          <a:xfrm>
            <a:off x="1105861" y="2337992"/>
            <a:ext cx="2224081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01" name="TextBox 100">
            <a:extLst>
              <a:ext uri="{FF2B5EF4-FFF2-40B4-BE49-F238E27FC236}">
                <a16:creationId xmlns:a16="http://schemas.microsoft.com/office/drawing/2014/main" id="{FDFF528D-DAFB-4FC0-B335-4BC28248A7FC}"/>
              </a:ext>
            </a:extLst>
          </p:cNvPr>
          <p:cNvSpPr txBox="1"/>
          <p:nvPr/>
        </p:nvSpPr>
        <p:spPr>
          <a:xfrm>
            <a:off x="1394252" y="1700127"/>
            <a:ext cx="42622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T-cell response to human coronaviru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C6A958F-36F7-A371-BEB0-3E24B49E8A5E}"/>
              </a:ext>
            </a:extLst>
          </p:cNvPr>
          <p:cNvSpPr txBox="1"/>
          <p:nvPr/>
        </p:nvSpPr>
        <p:spPr>
          <a:xfrm>
            <a:off x="60377" y="6148678"/>
            <a:ext cx="1015366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00" b="1"/>
            </a:lvl1pPr>
          </a:lstStyle>
          <a:p>
            <a:r>
              <a:rPr lang="en-US" sz="1200" dirty="0"/>
              <a:t>Supplementary Figure 1</a:t>
            </a:r>
            <a:r>
              <a:rPr lang="en-US" sz="1200" b="0" dirty="0"/>
              <a:t>: </a:t>
            </a:r>
            <a:r>
              <a:rPr lang="en-US" sz="1200" dirty="0"/>
              <a:t>A. </a:t>
            </a:r>
            <a:r>
              <a:rPr lang="en-US" sz="1200" b="0" dirty="0"/>
              <a:t>Gating strategy used for the analysis of antigen reactive T cells. </a:t>
            </a:r>
            <a:r>
              <a:rPr lang="en-US" sz="1200" dirty="0"/>
              <a:t>B. </a:t>
            </a:r>
            <a:r>
              <a:rPr lang="en-US" sz="1200" b="0" dirty="0"/>
              <a:t>In vitro T-cell response against immunodominant antigens from huma coronavirus. PBMCs collected post vaccination and before booster dose </a:t>
            </a:r>
            <a:r>
              <a:rPr lang="en-US" sz="1200" b="0"/>
              <a:t>(6 months </a:t>
            </a:r>
            <a:r>
              <a:rPr lang="en-US" sz="1200" b="0" dirty="0"/>
              <a:t>post vaccination) were stimulated with the indicated peptide libraries, cultured for 14 days and tested against the cognate antigens. 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00246904-DCBC-083E-3EAF-93A0BF5C15F2}"/>
              </a:ext>
            </a:extLst>
          </p:cNvPr>
          <p:cNvCxnSpPr>
            <a:cxnSpLocks/>
          </p:cNvCxnSpPr>
          <p:nvPr/>
        </p:nvCxnSpPr>
        <p:spPr>
          <a:xfrm>
            <a:off x="3570312" y="2337992"/>
            <a:ext cx="2298024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C83F50F4-71A4-E383-C05C-34E04058821A}"/>
              </a:ext>
            </a:extLst>
          </p:cNvPr>
          <p:cNvCxnSpPr>
            <a:cxnSpLocks/>
          </p:cNvCxnSpPr>
          <p:nvPr/>
        </p:nvCxnSpPr>
        <p:spPr>
          <a:xfrm flipV="1">
            <a:off x="300035" y="1030507"/>
            <a:ext cx="0" cy="41106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A56B3C0A-A57B-3EBD-B997-47E0EB7B5434}"/>
              </a:ext>
            </a:extLst>
          </p:cNvPr>
          <p:cNvCxnSpPr>
            <a:cxnSpLocks/>
          </p:cNvCxnSpPr>
          <p:nvPr/>
        </p:nvCxnSpPr>
        <p:spPr>
          <a:xfrm flipV="1">
            <a:off x="1692752" y="1030507"/>
            <a:ext cx="0" cy="41106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085E63CB-6267-8FE4-F68C-336777E34A8C}"/>
              </a:ext>
            </a:extLst>
          </p:cNvPr>
          <p:cNvCxnSpPr>
            <a:cxnSpLocks/>
          </p:cNvCxnSpPr>
          <p:nvPr/>
        </p:nvCxnSpPr>
        <p:spPr>
          <a:xfrm flipV="1">
            <a:off x="3152520" y="1030507"/>
            <a:ext cx="0" cy="41106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E2DC029F-ECE9-8E27-9DEA-5893FD9791C3}"/>
              </a:ext>
            </a:extLst>
          </p:cNvPr>
          <p:cNvCxnSpPr>
            <a:cxnSpLocks/>
          </p:cNvCxnSpPr>
          <p:nvPr/>
        </p:nvCxnSpPr>
        <p:spPr>
          <a:xfrm flipV="1">
            <a:off x="4617982" y="1030507"/>
            <a:ext cx="0" cy="41106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23A1FF65-A856-44BF-5600-EC805B8C2D20}"/>
              </a:ext>
            </a:extLst>
          </p:cNvPr>
          <p:cNvCxnSpPr/>
          <p:nvPr/>
        </p:nvCxnSpPr>
        <p:spPr>
          <a:xfrm>
            <a:off x="300035" y="1441567"/>
            <a:ext cx="32717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950200FE-875B-DAB6-0D90-425CB654F7D5}"/>
              </a:ext>
            </a:extLst>
          </p:cNvPr>
          <p:cNvCxnSpPr/>
          <p:nvPr/>
        </p:nvCxnSpPr>
        <p:spPr>
          <a:xfrm>
            <a:off x="1692752" y="1441567"/>
            <a:ext cx="32717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1F555803-2A83-6F2F-18CE-D15A15275C4C}"/>
              </a:ext>
            </a:extLst>
          </p:cNvPr>
          <p:cNvCxnSpPr/>
          <p:nvPr/>
        </p:nvCxnSpPr>
        <p:spPr>
          <a:xfrm>
            <a:off x="3152520" y="1441567"/>
            <a:ext cx="32717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E9639FC7-C723-574B-50AD-EDA3C446575E}"/>
              </a:ext>
            </a:extLst>
          </p:cNvPr>
          <p:cNvCxnSpPr/>
          <p:nvPr/>
        </p:nvCxnSpPr>
        <p:spPr>
          <a:xfrm>
            <a:off x="4617982" y="1451354"/>
            <a:ext cx="32717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837232B5-73BF-890B-61FA-9ADB8D904ADA}"/>
              </a:ext>
            </a:extLst>
          </p:cNvPr>
          <p:cNvSpPr txBox="1"/>
          <p:nvPr/>
        </p:nvSpPr>
        <p:spPr>
          <a:xfrm>
            <a:off x="562914" y="1319845"/>
            <a:ext cx="6185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FSC-A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A0ED8E2-295F-26B2-0DDF-40D65F0D1172}"/>
              </a:ext>
            </a:extLst>
          </p:cNvPr>
          <p:cNvSpPr txBox="1"/>
          <p:nvPr/>
        </p:nvSpPr>
        <p:spPr>
          <a:xfrm rot="16200000">
            <a:off x="29776" y="656620"/>
            <a:ext cx="5546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SSC-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DDCD279-08AC-416D-3293-49EA98CE2D68}"/>
              </a:ext>
            </a:extLst>
          </p:cNvPr>
          <p:cNvSpPr txBox="1"/>
          <p:nvPr/>
        </p:nvSpPr>
        <p:spPr>
          <a:xfrm>
            <a:off x="4709462" y="1320785"/>
            <a:ext cx="9469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FSC-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FE66F26-9A53-DD89-0C82-60E60B106E00}"/>
              </a:ext>
            </a:extLst>
          </p:cNvPr>
          <p:cNvSpPr txBox="1"/>
          <p:nvPr/>
        </p:nvSpPr>
        <p:spPr>
          <a:xfrm>
            <a:off x="1923683" y="1319845"/>
            <a:ext cx="6185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FSC-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826FD35-C4FB-6158-AB2E-0DAD58484C1C}"/>
              </a:ext>
            </a:extLst>
          </p:cNvPr>
          <p:cNvSpPr txBox="1"/>
          <p:nvPr/>
        </p:nvSpPr>
        <p:spPr>
          <a:xfrm rot="16200000">
            <a:off x="1390545" y="656620"/>
            <a:ext cx="5546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Liv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F3D47DA-8D96-4C91-AFF7-78620CE4A985}"/>
              </a:ext>
            </a:extLst>
          </p:cNvPr>
          <p:cNvSpPr txBox="1"/>
          <p:nvPr/>
        </p:nvSpPr>
        <p:spPr>
          <a:xfrm>
            <a:off x="3419693" y="1303067"/>
            <a:ext cx="6185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FSC-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F066F2E-ED27-705E-CAD9-A2F5A956357C}"/>
              </a:ext>
            </a:extLst>
          </p:cNvPr>
          <p:cNvSpPr txBox="1"/>
          <p:nvPr/>
        </p:nvSpPr>
        <p:spPr>
          <a:xfrm rot="16200000">
            <a:off x="2866201" y="611693"/>
            <a:ext cx="5546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FSC-H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A6443E9-0CEB-4317-A022-89A870E5B691}"/>
              </a:ext>
            </a:extLst>
          </p:cNvPr>
          <p:cNvSpPr txBox="1"/>
          <p:nvPr/>
        </p:nvSpPr>
        <p:spPr>
          <a:xfrm rot="16200000">
            <a:off x="4340638" y="661603"/>
            <a:ext cx="5546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CD3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65AC37D4-50AB-F764-027E-9B0C11C03FD9}"/>
              </a:ext>
            </a:extLst>
          </p:cNvPr>
          <p:cNvCxnSpPr>
            <a:cxnSpLocks/>
          </p:cNvCxnSpPr>
          <p:nvPr/>
        </p:nvCxnSpPr>
        <p:spPr>
          <a:xfrm>
            <a:off x="1183322" y="895638"/>
            <a:ext cx="33196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FE2492C6-0809-8AF2-6D98-3CF06C08F15E}"/>
              </a:ext>
            </a:extLst>
          </p:cNvPr>
          <p:cNvCxnSpPr>
            <a:cxnSpLocks/>
          </p:cNvCxnSpPr>
          <p:nvPr/>
        </p:nvCxnSpPr>
        <p:spPr>
          <a:xfrm>
            <a:off x="2564721" y="895638"/>
            <a:ext cx="33196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7A56602B-A13E-3842-EC37-7981CE04B286}"/>
              </a:ext>
            </a:extLst>
          </p:cNvPr>
          <p:cNvCxnSpPr>
            <a:cxnSpLocks/>
          </p:cNvCxnSpPr>
          <p:nvPr/>
        </p:nvCxnSpPr>
        <p:spPr>
          <a:xfrm>
            <a:off x="4026086" y="895638"/>
            <a:ext cx="33196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798CE507-06E7-19E3-F15A-5B30943813E0}"/>
              </a:ext>
            </a:extLst>
          </p:cNvPr>
          <p:cNvCxnSpPr>
            <a:cxnSpLocks/>
          </p:cNvCxnSpPr>
          <p:nvPr/>
        </p:nvCxnSpPr>
        <p:spPr>
          <a:xfrm flipV="1">
            <a:off x="7528404" y="1036746"/>
            <a:ext cx="0" cy="41106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83CEAE2A-8196-A9B0-D711-339A55BC7C18}"/>
              </a:ext>
            </a:extLst>
          </p:cNvPr>
          <p:cNvCxnSpPr/>
          <p:nvPr/>
        </p:nvCxnSpPr>
        <p:spPr>
          <a:xfrm>
            <a:off x="7528404" y="1457593"/>
            <a:ext cx="32717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C13CC360-FE87-3B59-EDDE-C2408F7D7ED8}"/>
              </a:ext>
            </a:extLst>
          </p:cNvPr>
          <p:cNvSpPr txBox="1"/>
          <p:nvPr/>
        </p:nvSpPr>
        <p:spPr>
          <a:xfrm>
            <a:off x="7619884" y="1327024"/>
            <a:ext cx="9469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TNFα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116DA999-9823-AB19-8F2A-3A6333EDD6FC}"/>
              </a:ext>
            </a:extLst>
          </p:cNvPr>
          <p:cNvSpPr txBox="1"/>
          <p:nvPr/>
        </p:nvSpPr>
        <p:spPr>
          <a:xfrm rot="16200000">
            <a:off x="7251060" y="667842"/>
            <a:ext cx="5546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CD4</a:t>
            </a:r>
          </a:p>
        </p:txBody>
      </p: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1C8993BF-EA57-A78A-45B6-D51BB8B6C80E}"/>
              </a:ext>
            </a:extLst>
          </p:cNvPr>
          <p:cNvCxnSpPr>
            <a:cxnSpLocks/>
          </p:cNvCxnSpPr>
          <p:nvPr/>
        </p:nvCxnSpPr>
        <p:spPr>
          <a:xfrm flipV="1">
            <a:off x="6084631" y="1022478"/>
            <a:ext cx="0" cy="41106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ECC4605E-4013-EEF6-0823-650AE823E82E}"/>
              </a:ext>
            </a:extLst>
          </p:cNvPr>
          <p:cNvCxnSpPr/>
          <p:nvPr/>
        </p:nvCxnSpPr>
        <p:spPr>
          <a:xfrm>
            <a:off x="6084631" y="1443325"/>
            <a:ext cx="32717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1780759F-8A34-4942-73E3-072EC42C5490}"/>
              </a:ext>
            </a:extLst>
          </p:cNvPr>
          <p:cNvSpPr txBox="1"/>
          <p:nvPr/>
        </p:nvSpPr>
        <p:spPr>
          <a:xfrm>
            <a:off x="6176111" y="1312756"/>
            <a:ext cx="9469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CD8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BAE1CB26-440B-4C61-217D-690A9A963325}"/>
              </a:ext>
            </a:extLst>
          </p:cNvPr>
          <p:cNvSpPr txBox="1"/>
          <p:nvPr/>
        </p:nvSpPr>
        <p:spPr>
          <a:xfrm rot="16200000">
            <a:off x="5807287" y="653574"/>
            <a:ext cx="5546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CD4</a:t>
            </a:r>
          </a:p>
        </p:txBody>
      </p: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33C82EE3-6500-5C4C-1735-35D2F717E0EF}"/>
              </a:ext>
            </a:extLst>
          </p:cNvPr>
          <p:cNvCxnSpPr>
            <a:cxnSpLocks/>
          </p:cNvCxnSpPr>
          <p:nvPr/>
        </p:nvCxnSpPr>
        <p:spPr>
          <a:xfrm>
            <a:off x="5522994" y="895638"/>
            <a:ext cx="33196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68D91B02-A141-3A1D-4735-C3C1722D987D}"/>
              </a:ext>
            </a:extLst>
          </p:cNvPr>
          <p:cNvCxnSpPr>
            <a:cxnSpLocks/>
          </p:cNvCxnSpPr>
          <p:nvPr/>
        </p:nvCxnSpPr>
        <p:spPr>
          <a:xfrm>
            <a:off x="6964250" y="895638"/>
            <a:ext cx="33196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5EEB5F63-F7AA-3019-5F5D-66233427BFF4}"/>
              </a:ext>
            </a:extLst>
          </p:cNvPr>
          <p:cNvSpPr txBox="1"/>
          <p:nvPr/>
        </p:nvSpPr>
        <p:spPr>
          <a:xfrm>
            <a:off x="60377" y="33503"/>
            <a:ext cx="63674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F22A309B-8ADA-6385-6E65-0E0ABD6379B6}"/>
              </a:ext>
            </a:extLst>
          </p:cNvPr>
          <p:cNvSpPr txBox="1"/>
          <p:nvPr/>
        </p:nvSpPr>
        <p:spPr>
          <a:xfrm>
            <a:off x="52967" y="1803245"/>
            <a:ext cx="63674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</a:p>
        </p:txBody>
      </p:sp>
      <p:pic>
        <p:nvPicPr>
          <p:cNvPr id="108" name="Picture 107">
            <a:extLst>
              <a:ext uri="{FF2B5EF4-FFF2-40B4-BE49-F238E27FC236}">
                <a16:creationId xmlns:a16="http://schemas.microsoft.com/office/drawing/2014/main" id="{6FD5E8DE-D05D-AD68-2CBB-A88E2D469E6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89730" y="519195"/>
            <a:ext cx="822960" cy="8229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769637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790</TotalTime>
  <Words>101</Words>
  <Application>Microsoft Office PowerPoint</Application>
  <PresentationFormat>Widescreen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ni, Mithil K.</dc:creator>
  <cp:lastModifiedBy>Miller, Maureen (NIH/CC/DTM) [E]</cp:lastModifiedBy>
  <cp:revision>33</cp:revision>
  <cp:lastPrinted>2022-12-13T17:59:45Z</cp:lastPrinted>
  <dcterms:created xsi:type="dcterms:W3CDTF">2021-10-20T20:36:09Z</dcterms:created>
  <dcterms:modified xsi:type="dcterms:W3CDTF">2023-06-06T13:18:59Z</dcterms:modified>
</cp:coreProperties>
</file>